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75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94EBC7-A431-D81E-E773-01C0EC9352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8E2B19-65B2-B34F-5B88-672CDB0045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8F400B-3D83-B375-D779-CEC28F34B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977570-5656-B35B-4160-88D537B1B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D7CE5F-83CB-2EE0-BD20-CF9E96382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7166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FA38F1-30FE-DDB1-9DE7-1F806BAC45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1F1499-8206-1771-2A75-4F7620CD10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8E5BE7-B7B7-D6B3-D478-5279DF569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4A8B7C-2BDB-488F-5539-C4CF0A1F2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D9FBCA-38AC-D396-EEFD-CB1E77F79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6466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63EDC8A-A3F8-9C80-5850-E3D5122AF4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79832D-6425-1C63-ABD3-593727D828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709BAD-1A8B-BE74-E574-734556A23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6EB92D-51FD-59E3-D326-AA1E9BD93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676035-807E-721B-9DC3-DD1B5CADC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3501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5D263F-3885-A4D4-CB14-E52F0DFFDE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18B2BD-A57F-17C8-A64F-1D0CF95467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B149A5-B10F-2F39-A086-DD4E0E30D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3CBB5C-8883-429B-2263-7BBF31EB4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6B195D-D688-AA0F-B9EF-CFD8698D2E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005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498887-7905-7A04-73A3-57251FAB08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0F1DDE-88FA-9CCC-8B93-95CD6447DF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4BDE9D-C925-D36A-CCAD-3E1EFCBC3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4EA8F4-804D-E8EE-6B97-1F8E24575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7B1B01-B777-6A1D-F00C-6380F623D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2081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56B163-A38A-703C-4B60-8BC43672D7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0761AA-274B-3134-BC8E-D52143865D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59C7CD-098D-4988-7E8D-7008E98287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1D6F35-9074-558E-022B-47051560F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3666C3-56BF-FE96-E8D2-9F5808D0A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6EEE14-1D29-2369-64CB-BAFF8E579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27791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8C9B8B-400F-467E-3D51-84DE99A247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BEDA2E-7E92-358A-BB9C-CC75FFA246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09D4B0-0607-A1C5-D98E-3B318A3992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C1C56F0-F609-9F94-F299-431121B09B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978985-0167-6214-5FF8-7D403EC40A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0194D8-01A7-7250-963D-C6989CCCE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93473C5-0114-21C3-D973-7982363AB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AFDE5AD-0232-BDD2-9704-69CEFAD258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8051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CC9429-DD3B-31C6-575F-CBEEBCAC04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062C45-60C4-032F-FE67-0361431F96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06CBB7-D043-3247-76A8-5D226EE71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F73C3BE-38A6-7B9F-F223-9239C3BB42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5023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D214A3-C6D6-B8CA-7BF3-5D15053690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D38F57C-4FF7-0A69-430D-F29AE9E30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60F1EF2-C175-7D51-C084-A571D16258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0519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FBFEA8-AF66-A873-A371-5B03FB3C1E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CF1715-A406-876B-CC2F-6492068608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48048B-7699-D79F-6DEF-075F768AD9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064C64-314E-3BF5-6E4D-BA041A3B4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3E6825-59E3-8A6F-7001-F984188D3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4AF5A0-D7A1-BBE2-E4C1-00464DDE15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8329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EA2032-F6A9-2581-A110-DBC6152A83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1245D39-9513-804A-5619-AD1DE36E05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B7B8B5-DBDA-93A1-9708-0EAF6C1954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1E419E-36C6-162F-2E5E-7313E5582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3FBF48-8B62-A576-643D-2C3680C8A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37CFBD-FABE-7CCC-6DCC-FA40CBC35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5187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9BE2B5C-CAA3-EC4E-A096-E622B79442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8E5BF1-0135-DEC4-143B-FB5B494D8C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54E90C-9340-9C05-46E1-076B4DF6C6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F4838-E7A9-40DD-A7EB-A84C96396297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41DD1F-7E3F-F9F7-EA62-9F2CCEB9AD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2B4971-3016-3EBF-6930-24F0FA9190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8DD04-910D-4A4E-9FF5-B080A1C9772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7412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DF1B549-B45B-4F19-6657-4DAB6616AB5E}"/>
              </a:ext>
            </a:extLst>
          </p:cNvPr>
          <p:cNvSpPr txBox="1"/>
          <p:nvPr/>
        </p:nvSpPr>
        <p:spPr>
          <a:xfrm>
            <a:off x="763574" y="5178366"/>
            <a:ext cx="11208470" cy="8785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800"/>
              </a:spcAft>
            </a:pPr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S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cording to treatment (regorafenib vs placebo) in patients with chemo-refractory mCRC in the CORRECT trial in patients with A) LDH low levels* or B) LDH high levels*.</a:t>
            </a: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509A105-911D-411C-AF45-A2A8DA014D48}"/>
              </a:ext>
            </a:extLst>
          </p:cNvPr>
          <p:cNvSpPr txBox="1"/>
          <p:nvPr/>
        </p:nvSpPr>
        <p:spPr>
          <a:xfrm>
            <a:off x="716439" y="5979426"/>
            <a:ext cx="11425287" cy="8785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800"/>
              </a:spcAft>
            </a:pP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LDH high, higher than the upper limit of normal; LDH low, lower than the upper limit of normal.</a:t>
            </a:r>
            <a:b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DH, lactate dehydrogenase; mCRC, metastatic colorectal cancer; OS, overall survival.</a:t>
            </a:r>
            <a:endParaRPr lang="fr-FR" sz="2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B6F3AF4B-7D9B-7865-362A-E1046B6EF29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088" y="687809"/>
            <a:ext cx="5624978" cy="38371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" name="Picture 1">
            <a:extLst>
              <a:ext uri="{FF2B5EF4-FFF2-40B4-BE49-F238E27FC236}">
                <a16:creationId xmlns:a16="http://schemas.microsoft.com/office/drawing/2014/main" id="{5098AF6D-FB0D-670E-B4AB-314B2991305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716090"/>
            <a:ext cx="5534185" cy="36834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3">
            <a:extLst>
              <a:ext uri="{FF2B5EF4-FFF2-40B4-BE49-F238E27FC236}">
                <a16:creationId xmlns:a16="http://schemas.microsoft.com/office/drawing/2014/main" id="{8FA8782D-12F6-391B-AEF8-F2E0FAA85B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7326" y="636294"/>
            <a:ext cx="31451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fr-FR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kumimoji="0" lang="fr-FR" altLang="fr-FR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altLang="fr-FR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Rectangle 4">
            <a:extLst>
              <a:ext uri="{FF2B5EF4-FFF2-40B4-BE49-F238E27FC236}">
                <a16:creationId xmlns:a16="http://schemas.microsoft.com/office/drawing/2014/main" id="{614AEE18-1E21-5CB3-DDE9-4B7A3ECE7B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8250" y="664576"/>
            <a:ext cx="31451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fr-FR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kumimoji="0" lang="fr-FR" altLang="fr-FR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altLang="fr-FR" sz="1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5">
            <a:extLst>
              <a:ext uri="{FF2B5EF4-FFF2-40B4-BE49-F238E27FC236}">
                <a16:creationId xmlns:a16="http://schemas.microsoft.com/office/drawing/2014/main" id="{48713584-ED4C-1007-F031-2E19760DBD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714692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fr-FR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LDH high, higher than the upper limit of normal; LDH low, lower than t</a:t>
            </a:r>
            <a:r>
              <a:rPr kumimoji="0" lang="fr-FR" altLang="fr-F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fr-FR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2546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8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ristophe Borg</dc:creator>
  <cp:lastModifiedBy>Christophe Borg</cp:lastModifiedBy>
  <cp:revision>1</cp:revision>
  <dcterms:created xsi:type="dcterms:W3CDTF">2024-11-02T17:48:19Z</dcterms:created>
  <dcterms:modified xsi:type="dcterms:W3CDTF">2024-11-02T17:49:52Z</dcterms:modified>
</cp:coreProperties>
</file>